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4" r:id="rId2"/>
    <p:sldId id="308" r:id="rId3"/>
    <p:sldId id="258" r:id="rId4"/>
    <p:sldId id="305" r:id="rId5"/>
    <p:sldId id="306" r:id="rId6"/>
    <p:sldId id="313" r:id="rId7"/>
    <p:sldId id="311" r:id="rId8"/>
    <p:sldId id="287" r:id="rId9"/>
    <p:sldId id="265" r:id="rId10"/>
    <p:sldId id="278" r:id="rId11"/>
    <p:sldId id="284" r:id="rId12"/>
    <p:sldId id="266" r:id="rId13"/>
    <p:sldId id="267" r:id="rId14"/>
    <p:sldId id="264" r:id="rId15"/>
  </p:sldIdLst>
  <p:sldSz cx="12192000" cy="7315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24" userDrawn="1">
          <p15:clr>
            <a:srgbClr val="A4A3A4"/>
          </p15:clr>
        </p15:guide>
        <p15:guide id="2" pos="39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3366FF"/>
    <a:srgbClr val="3333CC"/>
    <a:srgbClr val="A7A7AB"/>
    <a:srgbClr val="A56F22"/>
    <a:srgbClr val="F81480"/>
    <a:srgbClr val="0F9CB4"/>
    <a:srgbClr val="FF8400"/>
    <a:srgbClr val="B707F0"/>
    <a:srgbClr val="60DA6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60" y="816"/>
      </p:cViewPr>
      <p:guideLst>
        <p:guide orient="horz" pos="2424"/>
        <p:guide pos="39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97187"/>
            <a:ext cx="9144000" cy="254677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842174"/>
            <a:ext cx="9144000" cy="176614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56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552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89467"/>
            <a:ext cx="2628900" cy="61992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89467"/>
            <a:ext cx="7734300" cy="619929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90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686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823721"/>
            <a:ext cx="10515600" cy="304291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895428"/>
            <a:ext cx="10515600" cy="16001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100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947333"/>
            <a:ext cx="5181600" cy="46414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947333"/>
            <a:ext cx="5181600" cy="46414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344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89467"/>
            <a:ext cx="10515600" cy="14139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793241"/>
            <a:ext cx="5157787" cy="87883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672080"/>
            <a:ext cx="5157787" cy="39302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793241"/>
            <a:ext cx="5183188" cy="87883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672080"/>
            <a:ext cx="5183188" cy="39302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082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024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928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7680"/>
            <a:ext cx="3932237" cy="17068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53254"/>
            <a:ext cx="6172200" cy="519853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94560"/>
            <a:ext cx="3932237" cy="406569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888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7680"/>
            <a:ext cx="3932237" cy="17068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53254"/>
            <a:ext cx="6172200" cy="5198533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94560"/>
            <a:ext cx="3932237" cy="406569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395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89467"/>
            <a:ext cx="10515600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947333"/>
            <a:ext cx="10515600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780107"/>
            <a:ext cx="27432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FD147B-C26A-4331-AFD6-0291DB43D16B}" type="datetimeFigureOut">
              <a:rPr lang="en-US" smtClean="0"/>
              <a:t>7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780107"/>
            <a:ext cx="41148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780107"/>
            <a:ext cx="27432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50743-07CE-4337-9456-D0C878589B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615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2197" y="319359"/>
            <a:ext cx="8693624" cy="521617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BD50FE2-97D1-42F4-B2CA-4A8D505A2A94}"/>
              </a:ext>
            </a:extLst>
          </p:cNvPr>
          <p:cNvSpPr txBox="1"/>
          <p:nvPr/>
        </p:nvSpPr>
        <p:spPr>
          <a:xfrm>
            <a:off x="10762938" y="31746"/>
            <a:ext cx="1429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1903234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90E25FD-D086-4D5E-AD61-B501C0F9AB5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83" r="3286"/>
          <a:stretch/>
        </p:blipFill>
        <p:spPr>
          <a:xfrm>
            <a:off x="57150" y="574518"/>
            <a:ext cx="6117336" cy="327358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35E648A-468A-4D87-AE85-3DEDF7D1E9E9}"/>
              </a:ext>
            </a:extLst>
          </p:cNvPr>
          <p:cNvSpPr txBox="1"/>
          <p:nvPr/>
        </p:nvSpPr>
        <p:spPr>
          <a:xfrm>
            <a:off x="10777929" y="0"/>
            <a:ext cx="1414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10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91351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C72531E-F293-499C-B0A3-EA01D7702E2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180"/>
          <a:stretch/>
        </p:blipFill>
        <p:spPr>
          <a:xfrm>
            <a:off x="131064" y="214153"/>
            <a:ext cx="6117336" cy="326353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CF02D27-CE23-4E51-9ED1-92DA4E5F8FC6}"/>
              </a:ext>
            </a:extLst>
          </p:cNvPr>
          <p:cNvSpPr txBox="1"/>
          <p:nvPr/>
        </p:nvSpPr>
        <p:spPr>
          <a:xfrm>
            <a:off x="10822899" y="0"/>
            <a:ext cx="1369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1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25050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25A5AD9D-0D5C-4ACB-AA0B-3A0E41162C8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41" t="8712" r="-1"/>
          <a:stretch/>
        </p:blipFill>
        <p:spPr>
          <a:xfrm>
            <a:off x="142875" y="819150"/>
            <a:ext cx="6117336" cy="263482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131851A-B2D2-4AE9-9C93-3021FA840D00}"/>
              </a:ext>
            </a:extLst>
          </p:cNvPr>
          <p:cNvSpPr txBox="1"/>
          <p:nvPr/>
        </p:nvSpPr>
        <p:spPr>
          <a:xfrm>
            <a:off x="10762939" y="0"/>
            <a:ext cx="1429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1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55150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E8C65B1-7D12-4EE0-A2F9-8DE0649A1E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064" y="200026"/>
            <a:ext cx="6117336" cy="55429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84F4659-25C9-42DA-A81F-E29BCFC73508}"/>
              </a:ext>
            </a:extLst>
          </p:cNvPr>
          <p:cNvSpPr txBox="1"/>
          <p:nvPr/>
        </p:nvSpPr>
        <p:spPr>
          <a:xfrm>
            <a:off x="10807909" y="0"/>
            <a:ext cx="13840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13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766026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45">
            <a:extLst>
              <a:ext uri="{FF2B5EF4-FFF2-40B4-BE49-F238E27FC236}">
                <a16:creationId xmlns:a16="http://schemas.microsoft.com/office/drawing/2014/main" id="{F1A87CAE-469F-4AED-90D3-C3AF84232BB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23" t="4887" b="2240"/>
          <a:stretch/>
        </p:blipFill>
        <p:spPr>
          <a:xfrm>
            <a:off x="149413" y="354703"/>
            <a:ext cx="3054096" cy="112725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F7984F4-5863-41EC-A055-844C76A65660}"/>
              </a:ext>
            </a:extLst>
          </p:cNvPr>
          <p:cNvSpPr txBox="1"/>
          <p:nvPr/>
        </p:nvSpPr>
        <p:spPr>
          <a:xfrm>
            <a:off x="10732957" y="0"/>
            <a:ext cx="1459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14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03321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8AC8F22-C6B7-4413-9E47-44D3909DA9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01" t="4881" r="2443" b="2893"/>
          <a:stretch/>
        </p:blipFill>
        <p:spPr>
          <a:xfrm>
            <a:off x="790575" y="216412"/>
            <a:ext cx="3054096" cy="217680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BD50FE2-97D1-42F4-B2CA-4A8D505A2A94}"/>
              </a:ext>
            </a:extLst>
          </p:cNvPr>
          <p:cNvSpPr txBox="1"/>
          <p:nvPr/>
        </p:nvSpPr>
        <p:spPr>
          <a:xfrm>
            <a:off x="10762938" y="31746"/>
            <a:ext cx="1429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98601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AF6EFDB-9DBD-44EC-B0F6-EC082B11FD7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t="2972" r="1665" b="2107"/>
          <a:stretch/>
        </p:blipFill>
        <p:spPr>
          <a:xfrm>
            <a:off x="83598" y="671804"/>
            <a:ext cx="6117336" cy="275561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CEB3E51-601D-41CB-8298-9CC618018162}"/>
              </a:ext>
            </a:extLst>
          </p:cNvPr>
          <p:cNvSpPr txBox="1"/>
          <p:nvPr/>
        </p:nvSpPr>
        <p:spPr>
          <a:xfrm>
            <a:off x="10857875" y="0"/>
            <a:ext cx="1334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31467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47B7450-5492-4038-9CB1-BD919F9495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13" t="3332" b="3190"/>
          <a:stretch/>
        </p:blipFill>
        <p:spPr>
          <a:xfrm>
            <a:off x="175074" y="486999"/>
            <a:ext cx="3054096" cy="216896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15968DB-420A-4DCB-AB6A-218A33E52ADA}"/>
              </a:ext>
            </a:extLst>
          </p:cNvPr>
          <p:cNvSpPr txBox="1"/>
          <p:nvPr/>
        </p:nvSpPr>
        <p:spPr>
          <a:xfrm>
            <a:off x="10857875" y="0"/>
            <a:ext cx="1334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29774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B0719C5-A978-4573-B517-A9EAE8B6B72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71" t="6795" r="3991" b="2640"/>
          <a:stretch/>
        </p:blipFill>
        <p:spPr>
          <a:xfrm>
            <a:off x="166820" y="451985"/>
            <a:ext cx="3054096" cy="21442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CE43887-9EAC-46C4-B788-0E6A80D6FF7D}"/>
              </a:ext>
            </a:extLst>
          </p:cNvPr>
          <p:cNvSpPr txBox="1"/>
          <p:nvPr/>
        </p:nvSpPr>
        <p:spPr>
          <a:xfrm>
            <a:off x="10857875" y="0"/>
            <a:ext cx="1334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81680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82F9F98B-BA28-46B9-87A5-601D9BABAB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090" y="319302"/>
            <a:ext cx="6117336" cy="335702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1BC06D1-F615-4418-9441-6BBFD80A649D}"/>
              </a:ext>
            </a:extLst>
          </p:cNvPr>
          <p:cNvSpPr txBox="1"/>
          <p:nvPr/>
        </p:nvSpPr>
        <p:spPr>
          <a:xfrm>
            <a:off x="10857875" y="0"/>
            <a:ext cx="1334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51666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046BE84-D2E0-4BB4-A03F-4CE624C422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675" y="523324"/>
            <a:ext cx="6117336" cy="332477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25E17E4-0A14-4111-B911-406AD82F4215}"/>
              </a:ext>
            </a:extLst>
          </p:cNvPr>
          <p:cNvSpPr txBox="1"/>
          <p:nvPr/>
        </p:nvSpPr>
        <p:spPr>
          <a:xfrm>
            <a:off x="10857875" y="0"/>
            <a:ext cx="1334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19749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9CD7141-F30A-4484-909D-C90A74516DA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463"/>
          <a:stretch/>
        </p:blipFill>
        <p:spPr>
          <a:xfrm>
            <a:off x="131064" y="518662"/>
            <a:ext cx="6117336" cy="313893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7C29DE8-7DF9-481F-B3A8-19BC094922D0}"/>
              </a:ext>
            </a:extLst>
          </p:cNvPr>
          <p:cNvSpPr txBox="1"/>
          <p:nvPr/>
        </p:nvSpPr>
        <p:spPr>
          <a:xfrm>
            <a:off x="10777929" y="0"/>
            <a:ext cx="1414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60948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25B7C27-1CD2-4283-98B7-697F356B38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175" y="1492885"/>
            <a:ext cx="3054096" cy="432943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6A5843F-086D-45B2-BCB6-5495D264812B}"/>
              </a:ext>
            </a:extLst>
          </p:cNvPr>
          <p:cNvSpPr txBox="1"/>
          <p:nvPr/>
        </p:nvSpPr>
        <p:spPr>
          <a:xfrm>
            <a:off x="10658007" y="0"/>
            <a:ext cx="15339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5007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09</TotalTime>
  <Words>28</Words>
  <Application>Microsoft Office PowerPoint</Application>
  <PresentationFormat>Custom</PresentationFormat>
  <Paragraphs>14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exas A&amp;M Agrilife - Department of Entom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ggleston, Heather L</dc:creator>
  <cp:lastModifiedBy>Adelman, Zachary N</cp:lastModifiedBy>
  <cp:revision>319</cp:revision>
  <dcterms:created xsi:type="dcterms:W3CDTF">2019-11-05T22:14:53Z</dcterms:created>
  <dcterms:modified xsi:type="dcterms:W3CDTF">2020-07-29T13:59:26Z</dcterms:modified>
</cp:coreProperties>
</file>